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5E87B-59E5-4DC4-ACE6-0D5DCFE894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5701E-37CB-4AD7-BFDA-885855E1CB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6631F-BD44-4C8D-8D19-30A03CCB9D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9626D-8DD6-475C-94EC-0FD7100222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4F8CA-EC4B-418C-8213-56D7FD15D2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F39E9-1F07-4F41-9EAF-457BA6D3FB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CBA0E-83D7-4853-91F0-795B20139C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A2960-8C95-4D2A-8C28-D0ED7D9AAF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105A5-B928-40A8-A10E-DB901E3207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AA8CC8-2254-4214-A258-D451D80688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DB8861-71C4-444B-B3F1-18B8A84404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FA2C2-479F-4079-B951-BA3709EF69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51A973-247D-443A-80E8-C49CE260B836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1"/>
          <p:cNvSpPr/>
          <p:nvPr/>
        </p:nvSpPr>
        <p:spPr>
          <a:xfrm>
            <a:off x="551160" y="476280"/>
            <a:ext cx="2559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组合 7"/>
          <p:cNvGrpSpPr/>
          <p:nvPr/>
        </p:nvGrpSpPr>
        <p:grpSpPr>
          <a:xfrm>
            <a:off x="690840" y="1773360"/>
            <a:ext cx="3233520" cy="3275640"/>
            <a:chOff x="690840" y="1773360"/>
            <a:chExt cx="3233520" cy="3275640"/>
          </a:xfrm>
        </p:grpSpPr>
        <p:pic>
          <p:nvPicPr>
            <p:cNvPr id="43" name="图片 8" descr=""/>
            <p:cNvPicPr/>
            <p:nvPr/>
          </p:nvPicPr>
          <p:blipFill>
            <a:blip r:embed="rId1"/>
            <a:srcRect l="0" t="0" r="0" b="15943"/>
            <a:stretch/>
          </p:blipFill>
          <p:spPr>
            <a:xfrm flipH="1" rot="16200000">
              <a:off x="1340280" y="2464920"/>
              <a:ext cx="3241080" cy="1927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4" name="组合 9"/>
            <p:cNvGrpSpPr/>
            <p:nvPr/>
          </p:nvGrpSpPr>
          <p:grpSpPr>
            <a:xfrm>
              <a:off x="690840" y="1773360"/>
              <a:ext cx="1107360" cy="1016280"/>
              <a:chOff x="690840" y="1773360"/>
              <a:chExt cx="1107360" cy="1016280"/>
            </a:xfrm>
          </p:grpSpPr>
          <p:sp>
            <p:nvSpPr>
              <p:cNvPr id="45" name="文本框 18"/>
              <p:cNvSpPr/>
              <p:nvPr/>
            </p:nvSpPr>
            <p:spPr>
              <a:xfrm>
                <a:off x="690840" y="1773360"/>
                <a:ext cx="1107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C5314-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文本框 19"/>
              <p:cNvSpPr/>
              <p:nvPr/>
            </p:nvSpPr>
            <p:spPr>
              <a:xfrm>
                <a:off x="702360" y="2124000"/>
                <a:ext cx="802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X1-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文本框 20"/>
              <p:cNvSpPr/>
              <p:nvPr/>
            </p:nvSpPr>
            <p:spPr>
              <a:xfrm>
                <a:off x="702360" y="2421360"/>
                <a:ext cx="802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X2-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组合 10"/>
            <p:cNvGrpSpPr/>
            <p:nvPr/>
          </p:nvGrpSpPr>
          <p:grpSpPr>
            <a:xfrm>
              <a:off x="690840" y="2772000"/>
              <a:ext cx="1107360" cy="1016280"/>
              <a:chOff x="690840" y="2772000"/>
              <a:chExt cx="1107360" cy="1016280"/>
            </a:xfrm>
          </p:grpSpPr>
          <p:sp>
            <p:nvSpPr>
              <p:cNvPr id="49" name="文本框 15"/>
              <p:cNvSpPr/>
              <p:nvPr/>
            </p:nvSpPr>
            <p:spPr>
              <a:xfrm>
                <a:off x="690840" y="2772000"/>
                <a:ext cx="1107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C5314-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文本框 16"/>
              <p:cNvSpPr/>
              <p:nvPr/>
            </p:nvSpPr>
            <p:spPr>
              <a:xfrm>
                <a:off x="702360" y="3069000"/>
                <a:ext cx="802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X1-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文本框 17"/>
              <p:cNvSpPr/>
              <p:nvPr/>
            </p:nvSpPr>
            <p:spPr>
              <a:xfrm>
                <a:off x="702360" y="3420000"/>
                <a:ext cx="802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X2-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" name="组合 11"/>
            <p:cNvGrpSpPr/>
            <p:nvPr/>
          </p:nvGrpSpPr>
          <p:grpSpPr>
            <a:xfrm>
              <a:off x="690840" y="3717360"/>
              <a:ext cx="1107360" cy="1007280"/>
              <a:chOff x="690840" y="3717360"/>
              <a:chExt cx="1107360" cy="1007280"/>
            </a:xfrm>
          </p:grpSpPr>
          <p:sp>
            <p:nvSpPr>
              <p:cNvPr id="53" name="文本框 12"/>
              <p:cNvSpPr/>
              <p:nvPr/>
            </p:nvSpPr>
            <p:spPr>
              <a:xfrm>
                <a:off x="690840" y="3717360"/>
                <a:ext cx="1107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C5314-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文本框 13"/>
              <p:cNvSpPr/>
              <p:nvPr/>
            </p:nvSpPr>
            <p:spPr>
              <a:xfrm>
                <a:off x="702360" y="4005360"/>
                <a:ext cx="802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X1-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文本框 14"/>
              <p:cNvSpPr/>
              <p:nvPr/>
            </p:nvSpPr>
            <p:spPr>
              <a:xfrm>
                <a:off x="702360" y="4356360"/>
                <a:ext cx="802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X2-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56" name="图片 5" descr=""/>
          <p:cNvPicPr/>
          <p:nvPr/>
        </p:nvPicPr>
        <p:blipFill>
          <a:blip r:embed="rId2"/>
          <a:stretch/>
        </p:blipFill>
        <p:spPr>
          <a:xfrm>
            <a:off x="5003640" y="1946160"/>
            <a:ext cx="3648240" cy="3103560"/>
          </a:xfrm>
          <a:prstGeom prst="rect">
            <a:avLst/>
          </a:prstGeom>
          <a:ln w="0">
            <a:noFill/>
          </a:ln>
        </p:spPr>
      </p:pic>
      <p:sp>
        <p:nvSpPr>
          <p:cNvPr id="57" name="文本框 14"/>
          <p:cNvSpPr/>
          <p:nvPr/>
        </p:nvSpPr>
        <p:spPr>
          <a:xfrm>
            <a:off x="690480" y="471636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N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1"/>
          <p:cNvSpPr/>
          <p:nvPr/>
        </p:nvSpPr>
        <p:spPr>
          <a:xfrm>
            <a:off x="0" y="5516640"/>
            <a:ext cx="9036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biofilm formations of two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auris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solates and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albicans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ere performed in 96-well plates and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easured according to spectrophotometric methods using microplate reader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文本框 1"/>
          <p:cNvSpPr/>
          <p:nvPr/>
        </p:nvSpPr>
        <p:spPr>
          <a:xfrm>
            <a:off x="335160" y="333360"/>
            <a:ext cx="254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组合 2"/>
          <p:cNvGrpSpPr/>
          <p:nvPr/>
        </p:nvGrpSpPr>
        <p:grpSpPr>
          <a:xfrm>
            <a:off x="991440" y="1268280"/>
            <a:ext cx="7166880" cy="3883320"/>
            <a:chOff x="991440" y="1268280"/>
            <a:chExt cx="7166880" cy="3883320"/>
          </a:xfrm>
        </p:grpSpPr>
        <p:pic>
          <p:nvPicPr>
            <p:cNvPr id="61" name="图片 4" descr=""/>
            <p:cNvPicPr/>
            <p:nvPr/>
          </p:nvPicPr>
          <p:blipFill>
            <a:blip r:embed="rId1"/>
            <a:srcRect l="29743" t="38940" r="39694" b="38068"/>
            <a:stretch/>
          </p:blipFill>
          <p:spPr>
            <a:xfrm>
              <a:off x="2112120" y="1726560"/>
              <a:ext cx="6046200" cy="3425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文本框 5"/>
            <p:cNvSpPr/>
            <p:nvPr/>
          </p:nvSpPr>
          <p:spPr>
            <a:xfrm>
              <a:off x="991440" y="2136960"/>
              <a:ext cx="916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C531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文本框 6"/>
            <p:cNvSpPr/>
            <p:nvPr/>
          </p:nvSpPr>
          <p:spPr>
            <a:xfrm>
              <a:off x="1105560" y="3254040"/>
              <a:ext cx="688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-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文本框 7"/>
            <p:cNvSpPr/>
            <p:nvPr/>
          </p:nvSpPr>
          <p:spPr>
            <a:xfrm>
              <a:off x="1105560" y="4293360"/>
              <a:ext cx="688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-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文本框 1"/>
            <p:cNvSpPr/>
            <p:nvPr/>
          </p:nvSpPr>
          <p:spPr>
            <a:xfrm>
              <a:off x="2653560" y="1268280"/>
              <a:ext cx="52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文本框 7"/>
            <p:cNvSpPr/>
            <p:nvPr/>
          </p:nvSpPr>
          <p:spPr>
            <a:xfrm>
              <a:off x="3735000" y="1268280"/>
              <a:ext cx="52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文本框 8"/>
            <p:cNvSpPr/>
            <p:nvPr/>
          </p:nvSpPr>
          <p:spPr>
            <a:xfrm>
              <a:off x="4815360" y="1268280"/>
              <a:ext cx="52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文本框 9"/>
            <p:cNvSpPr/>
            <p:nvPr/>
          </p:nvSpPr>
          <p:spPr>
            <a:xfrm>
              <a:off x="5822640" y="1268280"/>
              <a:ext cx="52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文本框 10"/>
            <p:cNvSpPr/>
            <p:nvPr/>
          </p:nvSpPr>
          <p:spPr>
            <a:xfrm>
              <a:off x="6903000" y="1268280"/>
              <a:ext cx="52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-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文本框 3"/>
          <p:cNvSpPr/>
          <p:nvPr/>
        </p:nvSpPr>
        <p:spPr>
          <a:xfrm>
            <a:off x="282600" y="5497560"/>
            <a:ext cx="916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 spot dilution assay was performed to compare growth status of two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C.auris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isolates and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C.albicans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. Serial dilutions were spotted on YPD agar plates and cultured for 4 days at 30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℃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4-02T07:08:25Z</dcterms:created>
  <dc:creator>周文凯</dc:creator>
  <dc:description/>
  <dc:language>en-US</dc:language>
  <cp:lastModifiedBy>周 文凯</cp:lastModifiedBy>
  <dcterms:modified xsi:type="dcterms:W3CDTF">2021-04-12T10:24:13Z</dcterms:modified>
  <cp:revision>10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